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4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Francisco\Desktop\Copie%20de%20S1%20Table%202_Danie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3!$N$2</c:f>
              <c:strCache>
                <c:ptCount val="1"/>
                <c:pt idx="0">
                  <c:v>Fréquence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1200" baseline="0"/>
                </a:pPr>
                <a:endParaRPr lang="fr-F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</c:ext>
            </c:extLst>
          </c:dLbls>
          <c:val>
            <c:numRef>
              <c:f>Feuil3!$N$3:$N$10</c:f>
              <c:numCache>
                <c:formatCode>General</c:formatCode>
                <c:ptCount val="8"/>
                <c:pt idx="0">
                  <c:v>64</c:v>
                </c:pt>
                <c:pt idx="1">
                  <c:v>32</c:v>
                </c:pt>
                <c:pt idx="2">
                  <c:v>26</c:v>
                </c:pt>
                <c:pt idx="3">
                  <c:v>2</c:v>
                </c:pt>
                <c:pt idx="4">
                  <c:v>3</c:v>
                </c:pt>
                <c:pt idx="5">
                  <c:v>2</c:v>
                </c:pt>
                <c:pt idx="6">
                  <c:v>1</c:v>
                </c:pt>
                <c:pt idx="7">
                  <c:v>1</c:v>
                </c:pt>
              </c:numCache>
            </c:numRef>
          </c:val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70"/>
        <c:axId val="708813744"/>
        <c:axId val="708814832"/>
      </c:barChart>
      <c:catAx>
        <c:axId val="7088137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aseline="0">
                    <a:latin typeface="Times New Roman" panose="02020603050405020304" pitchFamily="18" charset="0"/>
                  </a:defRPr>
                </a:pPr>
                <a:r>
                  <a:rPr lang="fr-FR" sz="1400" baseline="0">
                    <a:latin typeface="Times New Roman" panose="02020603050405020304" pitchFamily="18" charset="0"/>
                  </a:rPr>
                  <a:t>N° of pathways</a:t>
                </a:r>
              </a:p>
            </c:rich>
          </c:tx>
          <c:layout>
            <c:manualLayout>
              <c:xMode val="edge"/>
              <c:yMode val="edge"/>
              <c:x val="0.41288810779144691"/>
              <c:y val="0.9434599156118143"/>
            </c:manualLayout>
          </c:layout>
          <c:overlay val="0"/>
        </c:title>
        <c:majorTickMark val="out"/>
        <c:minorTickMark val="none"/>
        <c:tickLblPos val="nextTo"/>
        <c:spPr>
          <a:ln w="19050"/>
        </c:spPr>
        <c:txPr>
          <a:bodyPr/>
          <a:lstStyle/>
          <a:p>
            <a:pPr>
              <a:defRPr sz="1200" b="1" i="0" baseline="0">
                <a:latin typeface="Times New Roman" panose="02020603050405020304" pitchFamily="18" charset="0"/>
              </a:defRPr>
            </a:pPr>
            <a:endParaRPr lang="fr-FR"/>
          </a:p>
        </c:txPr>
        <c:crossAx val="708814832"/>
        <c:crosses val="autoZero"/>
        <c:auto val="1"/>
        <c:lblAlgn val="ctr"/>
        <c:lblOffset val="100"/>
        <c:noMultiLvlLbl val="0"/>
      </c:catAx>
      <c:valAx>
        <c:axId val="708814832"/>
        <c:scaling>
          <c:orientation val="minMax"/>
        </c:scaling>
        <c:delete val="0"/>
        <c:axPos val="l"/>
        <c:majorGridlines>
          <c:spPr>
            <a:ln>
              <a:prstDash val="dash"/>
            </a:ln>
          </c:spPr>
        </c:majorGridlines>
        <c:title>
          <c:tx>
            <c:rich>
              <a:bodyPr/>
              <a:lstStyle/>
              <a:p>
                <a:pPr>
                  <a:defRPr sz="1200" baseline="0">
                    <a:latin typeface="Times New Roman" panose="02020603050405020304" pitchFamily="18" charset="0"/>
                  </a:defRPr>
                </a:pPr>
                <a:r>
                  <a:rPr lang="fr-FR" sz="1400" baseline="0">
                    <a:latin typeface="Times New Roman" panose="02020603050405020304" pitchFamily="18" charset="0"/>
                  </a:rPr>
                  <a:t>N° of genes</a:t>
                </a:r>
              </a:p>
            </c:rich>
          </c:tx>
          <c:layout>
            <c:manualLayout>
              <c:xMode val="edge"/>
              <c:yMode val="edge"/>
              <c:x val="4.6865846514352666E-3"/>
              <c:y val="0.3840577206330221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9050"/>
        </c:spPr>
        <c:txPr>
          <a:bodyPr/>
          <a:lstStyle/>
          <a:p>
            <a:pPr>
              <a:defRPr sz="1200" b="1" i="0" baseline="0">
                <a:latin typeface="Times New Roman" panose="02020603050405020304" pitchFamily="18" charset="0"/>
              </a:defRPr>
            </a:pPr>
            <a:endParaRPr lang="fr-FR"/>
          </a:p>
        </c:txPr>
        <c:crossAx val="708813744"/>
        <c:crosses val="autoZero"/>
        <c:crossBetween val="between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4B717-C533-40C7-A07D-1A090AA44E57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E598D-9947-45D9-A644-0ECFE243D6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0573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4B717-C533-40C7-A07D-1A090AA44E57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E598D-9947-45D9-A644-0ECFE243D6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507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4B717-C533-40C7-A07D-1A090AA44E57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E598D-9947-45D9-A644-0ECFE243D6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7075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4B717-C533-40C7-A07D-1A090AA44E57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E598D-9947-45D9-A644-0ECFE243D6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1727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4B717-C533-40C7-A07D-1A090AA44E57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E598D-9947-45D9-A644-0ECFE243D6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9020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4B717-C533-40C7-A07D-1A090AA44E57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E598D-9947-45D9-A644-0ECFE243D6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0774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4B717-C533-40C7-A07D-1A090AA44E57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E598D-9947-45D9-A644-0ECFE243D6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6602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4B717-C533-40C7-A07D-1A090AA44E57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E598D-9947-45D9-A644-0ECFE243D6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08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4B717-C533-40C7-A07D-1A090AA44E57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E598D-9947-45D9-A644-0ECFE243D6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2333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4B717-C533-40C7-A07D-1A090AA44E57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E598D-9947-45D9-A644-0ECFE243D6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490089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4B717-C533-40C7-A07D-1A090AA44E57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0E598D-9947-45D9-A644-0ECFE243D6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7887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4B717-C533-40C7-A07D-1A090AA44E57}" type="datetimeFigureOut">
              <a:rPr lang="fr-FR" smtClean="0"/>
              <a:t>17/10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0E598D-9947-45D9-A644-0ECFE243D61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6722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0943268"/>
              </p:ext>
            </p:extLst>
          </p:nvPr>
        </p:nvGraphicFramePr>
        <p:xfrm>
          <a:off x="3386137" y="1171575"/>
          <a:ext cx="4958793" cy="39605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1342769" y="5593490"/>
            <a:ext cx="954765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lang="en-US" b="1" dirty="0"/>
              <a:t> The histogram of gene frequency in the pathways associated with the DEGs. </a:t>
            </a:r>
            <a:r>
              <a:rPr lang="en-US" dirty="0"/>
              <a:t>The histogram shows how often a single DEG identified in the pathway enrichment analysis appears in the different pathways.</a:t>
            </a:r>
            <a:r>
              <a:rPr lang="fr-F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FR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571798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4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rancisco</dc:creator>
  <cp:lastModifiedBy>Francisco</cp:lastModifiedBy>
  <cp:revision>3</cp:revision>
  <dcterms:created xsi:type="dcterms:W3CDTF">2016-10-12T09:17:58Z</dcterms:created>
  <dcterms:modified xsi:type="dcterms:W3CDTF">2016-10-17T09:16:14Z</dcterms:modified>
</cp:coreProperties>
</file>